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801600" cy="12801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715760" y="685440"/>
            <a:ext cx="3427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199F1DBB-D185-4599-9B5E-83E41888EA2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716120" y="685800"/>
            <a:ext cx="342756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88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1C1078C2-5D82-4342-9DCC-148BACC2404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F1462-0411-435D-AA5B-DDECDF486A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720" y="739980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7C14C-8B19-484F-B803-5459C01447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543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E92E3-44FE-49EC-8891-EF9DB4CBC6E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53528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431200" y="298764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72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53528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431200" y="7399800"/>
            <a:ext cx="370980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B96D5-307D-4F6C-A231-2081851CA3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76"/>
              </a:spcBef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C2919-A9A0-4491-9D83-BBB9E0E6F8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B4574-A86C-4FC5-BE11-981BFEA47A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C32F0-1E19-4982-99A1-785B2E84A4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6961E-C189-4E60-B3F1-397CAB74C5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720" y="512280"/>
            <a:ext cx="11522160" cy="989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76"/>
              </a:spcBef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CD7AB-9036-4CDE-9ED4-C4E8EE92CA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0A1E1-6A66-4E9D-90ED-007BF8112E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543720" y="739980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F0CEAD-763C-471B-B733-21E9CBFF1F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543720" y="2987640"/>
            <a:ext cx="562248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720" y="7399800"/>
            <a:ext cx="11522160" cy="4029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76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080F86-11FC-4E08-B240-A89BCFD861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720" y="512280"/>
            <a:ext cx="11522160" cy="21337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70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7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720" y="2987640"/>
            <a:ext cx="11522160" cy="844704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marL="547560" indent="-54756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1" marL="1187280" indent="-45720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2" marL="1828800" indent="-365040">
              <a:spcBef>
                <a:spcPts val="1276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3" marL="2558880" indent="-365040">
              <a:spcBef>
                <a:spcPts val="1276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4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5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  <a:p>
            <a:pPr lvl="6" marL="3290760" indent="-365040">
              <a:spcBef>
                <a:spcPts val="1276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11864880"/>
            <a:ext cx="298764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373640" y="11864880"/>
            <a:ext cx="405432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173880" y="11864880"/>
            <a:ext cx="2987640" cy="68112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fld id="{40E867CC-DED9-4398-B2EC-EA192A793DDA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tangolo 33"/>
          <p:cNvSpPr/>
          <p:nvPr/>
        </p:nvSpPr>
        <p:spPr>
          <a:xfrm>
            <a:off x="58680" y="3340080"/>
            <a:ext cx="12503160" cy="5127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CasellaDiTesto 25"/>
          <p:cNvSpPr/>
          <p:nvPr/>
        </p:nvSpPr>
        <p:spPr>
          <a:xfrm rot="16200000">
            <a:off x="3089160" y="4019400"/>
            <a:ext cx="136836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DNA ladd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BM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Jurkat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CasellaDiTesto 24"/>
          <p:cNvSpPr/>
          <p:nvPr/>
        </p:nvSpPr>
        <p:spPr>
          <a:xfrm>
            <a:off x="3538440" y="3662280"/>
            <a:ext cx="1613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2000" spc="-1" strike="noStrike">
                <a:solidFill>
                  <a:srgbClr val="000000"/>
                </a:solidFill>
                <a:latin typeface="Arial"/>
                <a:ea typeface="Arial"/>
              </a:rPr>
              <a:t>S1P2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88"/>
          <p:cNvSpPr/>
          <p:nvPr/>
        </p:nvSpPr>
        <p:spPr>
          <a:xfrm>
            <a:off x="4182120" y="4911840"/>
            <a:ext cx="127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   2   3   4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CasellaDiTesto 24"/>
          <p:cNvSpPr/>
          <p:nvPr/>
        </p:nvSpPr>
        <p:spPr>
          <a:xfrm>
            <a:off x="4005360" y="4535640"/>
            <a:ext cx="161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C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33"/>
          <p:cNvSpPr/>
          <p:nvPr/>
        </p:nvSpPr>
        <p:spPr>
          <a:xfrm>
            <a:off x="4232160" y="4890960"/>
            <a:ext cx="118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2" descr="E:\RT PCRagarose gel\S1PR1_3bis.jpg"/>
          <p:cNvPicPr/>
          <p:nvPr/>
        </p:nvPicPr>
        <p:blipFill>
          <a:blip r:embed="rId1"/>
          <a:srcRect l="14133" t="36019" r="47391" b="22720"/>
          <a:stretch/>
        </p:blipFill>
        <p:spPr>
          <a:xfrm>
            <a:off x="1017720" y="5202360"/>
            <a:ext cx="2111400" cy="25606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2" descr="Z:\RTPCR\RT PCRagarose gel\RT PCRagarose gel\S1PR2\S1PR2_1_bis.jpg"/>
          <p:cNvPicPr/>
          <p:nvPr/>
        </p:nvPicPr>
        <p:blipFill>
          <a:blip r:embed="rId2"/>
          <a:srcRect l="17244" t="17138" r="27100" b="35988"/>
          <a:stretch/>
        </p:blipFill>
        <p:spPr>
          <a:xfrm>
            <a:off x="3176640" y="5202360"/>
            <a:ext cx="2325600" cy="25606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5" descr=""/>
          <p:cNvPicPr/>
          <p:nvPr/>
        </p:nvPicPr>
        <p:blipFill>
          <a:blip r:embed="rId3"/>
          <a:srcRect l="29937" t="29739" r="35841" b="36300"/>
          <a:stretch/>
        </p:blipFill>
        <p:spPr>
          <a:xfrm>
            <a:off x="5551560" y="5202360"/>
            <a:ext cx="2100240" cy="25606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" descr="E:\RT PCRagarose gel\R4 07.11.16_bis_fig.jpg"/>
          <p:cNvPicPr/>
          <p:nvPr/>
        </p:nvPicPr>
        <p:blipFill>
          <a:blip r:embed="rId4"/>
          <a:srcRect l="36066" t="39045" r="31005" b="22340"/>
          <a:stretch/>
        </p:blipFill>
        <p:spPr>
          <a:xfrm>
            <a:off x="7682040" y="5202360"/>
            <a:ext cx="2143080" cy="25606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" descr="Z:\RTPCR\RT PCRagarose gel\RT PCRagarose gel\S1PR5\S1PR5_1.jpg"/>
          <p:cNvPicPr/>
          <p:nvPr/>
        </p:nvPicPr>
        <p:blipFill>
          <a:blip r:embed="rId5"/>
          <a:srcRect l="9961" t="25063" r="35192" b="36217"/>
          <a:stretch/>
        </p:blipFill>
        <p:spPr>
          <a:xfrm>
            <a:off x="9866160" y="5202360"/>
            <a:ext cx="2302200" cy="2560680"/>
          </a:xfrm>
          <a:prstGeom prst="rect">
            <a:avLst/>
          </a:prstGeom>
          <a:ln w="0">
            <a:noFill/>
          </a:ln>
        </p:spPr>
      </p:pic>
      <p:sp>
        <p:nvSpPr>
          <p:cNvPr id="59" name="CasellaDiTesto 25"/>
          <p:cNvSpPr/>
          <p:nvPr/>
        </p:nvSpPr>
        <p:spPr>
          <a:xfrm rot="16200000">
            <a:off x="816840" y="4300920"/>
            <a:ext cx="1236960" cy="56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DNA ladd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Jurkat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CasellaDiTesto 24"/>
          <p:cNvSpPr/>
          <p:nvPr/>
        </p:nvSpPr>
        <p:spPr>
          <a:xfrm>
            <a:off x="1273320" y="3662280"/>
            <a:ext cx="1612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2000" spc="-1" strike="noStrike">
                <a:solidFill>
                  <a:srgbClr val="000000"/>
                </a:solidFill>
                <a:latin typeface="Arial"/>
                <a:ea typeface="Arial"/>
              </a:rPr>
              <a:t>S1P1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"/>
          <p:cNvSpPr/>
          <p:nvPr/>
        </p:nvSpPr>
        <p:spPr>
          <a:xfrm>
            <a:off x="1739880" y="4911840"/>
            <a:ext cx="127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   2   3   4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asellaDiTesto 24"/>
          <p:cNvSpPr/>
          <p:nvPr/>
        </p:nvSpPr>
        <p:spPr>
          <a:xfrm>
            <a:off x="1563840" y="4535640"/>
            <a:ext cx="161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C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33"/>
          <p:cNvSpPr/>
          <p:nvPr/>
        </p:nvSpPr>
        <p:spPr>
          <a:xfrm>
            <a:off x="1789200" y="4890960"/>
            <a:ext cx="118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asellaDiTesto 24"/>
          <p:cNvSpPr/>
          <p:nvPr/>
        </p:nvSpPr>
        <p:spPr>
          <a:xfrm>
            <a:off x="258840" y="5973840"/>
            <a:ext cx="898560" cy="99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600bp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300bp 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100bp 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CasellaDiTesto 25"/>
          <p:cNvSpPr/>
          <p:nvPr/>
        </p:nvSpPr>
        <p:spPr>
          <a:xfrm rot="16200000">
            <a:off x="5224680" y="4250880"/>
            <a:ext cx="1238400" cy="56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DNA ladd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Jurkat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sellaDiTesto 24"/>
          <p:cNvSpPr/>
          <p:nvPr/>
        </p:nvSpPr>
        <p:spPr>
          <a:xfrm>
            <a:off x="5680080" y="3662280"/>
            <a:ext cx="1612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2000" spc="-1" strike="noStrike">
                <a:solidFill>
                  <a:srgbClr val="000000"/>
                </a:solidFill>
                <a:latin typeface="Arial"/>
                <a:ea typeface="Arial"/>
              </a:rPr>
              <a:t>S1P3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97"/>
          <p:cNvSpPr/>
          <p:nvPr/>
        </p:nvSpPr>
        <p:spPr>
          <a:xfrm>
            <a:off x="6147360" y="4911840"/>
            <a:ext cx="143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    2   3    4 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CasellaDiTesto 24"/>
          <p:cNvSpPr/>
          <p:nvPr/>
        </p:nvSpPr>
        <p:spPr>
          <a:xfrm>
            <a:off x="5972040" y="4535640"/>
            <a:ext cx="161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C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33"/>
          <p:cNvSpPr/>
          <p:nvPr/>
        </p:nvSpPr>
        <p:spPr>
          <a:xfrm>
            <a:off x="6265800" y="4890960"/>
            <a:ext cx="118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CasellaDiTesto 25"/>
          <p:cNvSpPr/>
          <p:nvPr/>
        </p:nvSpPr>
        <p:spPr>
          <a:xfrm rot="16200000">
            <a:off x="7413120" y="4309920"/>
            <a:ext cx="123804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DNA ladd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Jurkat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CasellaDiTesto 24"/>
          <p:cNvSpPr/>
          <p:nvPr/>
        </p:nvSpPr>
        <p:spPr>
          <a:xfrm>
            <a:off x="8107200" y="3662280"/>
            <a:ext cx="1613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2000" spc="-1" strike="noStrike">
                <a:solidFill>
                  <a:srgbClr val="000000"/>
                </a:solidFill>
                <a:latin typeface="Arial"/>
                <a:ea typeface="Arial"/>
              </a:rPr>
              <a:t>S1P4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02"/>
          <p:cNvSpPr/>
          <p:nvPr/>
        </p:nvSpPr>
        <p:spPr>
          <a:xfrm>
            <a:off x="8336520" y="4935600"/>
            <a:ext cx="143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    2   3    4 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CasellaDiTesto 24"/>
          <p:cNvSpPr/>
          <p:nvPr/>
        </p:nvSpPr>
        <p:spPr>
          <a:xfrm>
            <a:off x="8211960" y="4560840"/>
            <a:ext cx="161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C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33"/>
          <p:cNvSpPr/>
          <p:nvPr/>
        </p:nvSpPr>
        <p:spPr>
          <a:xfrm>
            <a:off x="8454960" y="4915080"/>
            <a:ext cx="118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CasellaDiTesto 25"/>
          <p:cNvSpPr/>
          <p:nvPr/>
        </p:nvSpPr>
        <p:spPr>
          <a:xfrm rot="16200000">
            <a:off x="9879840" y="4115520"/>
            <a:ext cx="11887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DNA ladder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BM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Jurkat cel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sellaDiTesto 24"/>
          <p:cNvSpPr/>
          <p:nvPr/>
        </p:nvSpPr>
        <p:spPr>
          <a:xfrm>
            <a:off x="10239480" y="3668760"/>
            <a:ext cx="1612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2000" spc="-1" strike="noStrike">
                <a:solidFill>
                  <a:srgbClr val="000000"/>
                </a:solidFill>
                <a:latin typeface="Arial"/>
                <a:ea typeface="Arial"/>
              </a:rPr>
              <a:t>S1P5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108"/>
          <p:cNvSpPr/>
          <p:nvPr/>
        </p:nvSpPr>
        <p:spPr>
          <a:xfrm>
            <a:off x="10883160" y="4917960"/>
            <a:ext cx="127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   2   3   4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CasellaDiTesto 24"/>
          <p:cNvSpPr/>
          <p:nvPr/>
        </p:nvSpPr>
        <p:spPr>
          <a:xfrm>
            <a:off x="10706040" y="4541760"/>
            <a:ext cx="161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CMSC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Straight Connector 33"/>
          <p:cNvSpPr/>
          <p:nvPr/>
        </p:nvSpPr>
        <p:spPr>
          <a:xfrm>
            <a:off x="10933200" y="4897440"/>
            <a:ext cx="1187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3T08:48:02Z</dcterms:created>
  <dc:creator>Giulio Innamorati</dc:creator>
  <dc:description/>
  <dc:language>en-US</dc:language>
  <cp:lastModifiedBy>shanmugam.s</cp:lastModifiedBy>
  <cp:lastPrinted>2017-01-10T10:08:55Z</cp:lastPrinted>
  <dcterms:modified xsi:type="dcterms:W3CDTF">2017-07-07T14:33:45Z</dcterms:modified>
  <cp:revision>363</cp:revision>
  <dc:subject/>
  <dc:title>PowerPoint Presentation</dc:title>
</cp:coreProperties>
</file>